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1828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34" autoAdjust="0"/>
    <p:restoredTop sz="94660"/>
  </p:normalViewPr>
  <p:slideViewPr>
    <p:cSldViewPr snapToGrid="0">
      <p:cViewPr>
        <p:scale>
          <a:sx n="60" d="100"/>
          <a:sy n="60" d="100"/>
        </p:scale>
        <p:origin x="1134" y="-42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992968"/>
            <a:ext cx="7772400" cy="636693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9605435"/>
            <a:ext cx="6858000" cy="44153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52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068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973667"/>
            <a:ext cx="1971675" cy="1549823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973667"/>
            <a:ext cx="5800725" cy="1549823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313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353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4559305"/>
            <a:ext cx="7886700" cy="760729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2238572"/>
            <a:ext cx="7886700" cy="40004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113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4868333"/>
            <a:ext cx="3886200" cy="1160356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4868333"/>
            <a:ext cx="3886200" cy="1160356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71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73671"/>
            <a:ext cx="7886700" cy="353483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4483101"/>
            <a:ext cx="3868340" cy="21970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6680200"/>
            <a:ext cx="3868340" cy="982556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4483101"/>
            <a:ext cx="3887391" cy="21970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6680200"/>
            <a:ext cx="3887391" cy="982556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460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644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687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219200"/>
            <a:ext cx="2949178" cy="4267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633138"/>
            <a:ext cx="4629150" cy="129963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5486400"/>
            <a:ext cx="2949178" cy="1016423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15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219200"/>
            <a:ext cx="2949178" cy="4267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633138"/>
            <a:ext cx="4629150" cy="129963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5486400"/>
            <a:ext cx="2949178" cy="1016423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08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973671"/>
            <a:ext cx="7886700" cy="35348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4868333"/>
            <a:ext cx="7886700" cy="1160356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6950271"/>
            <a:ext cx="205740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23037-018C-4A6C-A015-B464F82EDB01}" type="datetimeFigureOut">
              <a:rPr lang="en-US" smtClean="0"/>
              <a:t>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6950271"/>
            <a:ext cx="308610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6950271"/>
            <a:ext cx="205740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003E7-9B60-4CC0-94DE-228D97E65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606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urved Connector 4"/>
          <p:cNvCxnSpPr/>
          <p:nvPr/>
        </p:nvCxnSpPr>
        <p:spPr>
          <a:xfrm>
            <a:off x="2185871" y="10713643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956103" y="589507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>
            <a:stCxn id="7" idx="2"/>
          </p:cNvCxnSpPr>
          <p:nvPr/>
        </p:nvCxnSpPr>
        <p:spPr>
          <a:xfrm>
            <a:off x="4270452" y="1420504"/>
            <a:ext cx="0" cy="1201003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215762" y="1703308"/>
            <a:ext cx="20171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Is56; daf-7(e1372)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+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51334" y="1702303"/>
            <a:ext cx="3020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k-1(tm1944); aak-2(ok524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651303" y="2763746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270452" y="3299042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651303" y="4231639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/>
          <p:cNvCxnSpPr>
            <a:endCxn id="19" idx="0"/>
          </p:cNvCxnSpPr>
          <p:nvPr/>
        </p:nvCxnSpPr>
        <p:spPr>
          <a:xfrm>
            <a:off x="4250875" y="10012130"/>
            <a:ext cx="0" cy="1135105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208922" y="2652711"/>
            <a:ext cx="3499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at 25C to induce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worms that are non-quiescent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151334" y="4120604"/>
            <a:ext cx="36984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isolates at 15C, then heat shock 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males</a:t>
            </a:r>
          </a:p>
        </p:txBody>
      </p:sp>
      <p:cxnSp>
        <p:nvCxnSpPr>
          <p:cNvPr id="17" name="Curved Connector 16"/>
          <p:cNvCxnSpPr/>
          <p:nvPr/>
        </p:nvCxnSpPr>
        <p:spPr>
          <a:xfrm>
            <a:off x="6969155" y="10977528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urved Connector 17"/>
          <p:cNvCxnSpPr/>
          <p:nvPr/>
        </p:nvCxnSpPr>
        <p:spPr>
          <a:xfrm>
            <a:off x="2273353" y="11178046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936526" y="11147235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640951" y="12259511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262875" y="12193595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Curved Connector 21"/>
          <p:cNvCxnSpPr/>
          <p:nvPr/>
        </p:nvCxnSpPr>
        <p:spPr>
          <a:xfrm>
            <a:off x="6547823" y="11004436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urved Connector 22"/>
          <p:cNvCxnSpPr/>
          <p:nvPr/>
        </p:nvCxnSpPr>
        <p:spPr>
          <a:xfrm>
            <a:off x="7482543" y="11212884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urved Connector 23"/>
          <p:cNvCxnSpPr/>
          <p:nvPr/>
        </p:nvCxnSpPr>
        <p:spPr>
          <a:xfrm>
            <a:off x="1984664" y="11231803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3651303" y="8017694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4270452" y="8552990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3651303" y="9485587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4289346" y="4749934"/>
            <a:ext cx="0" cy="1135105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208922" y="7906659"/>
            <a:ext cx="3499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at 25C to induce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worms that are non-quiescent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151334" y="9374552"/>
            <a:ext cx="36984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isolates at 15C, then heat shock 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males</a:t>
            </a: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4263544" y="6725081"/>
            <a:ext cx="0" cy="1201003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16613" y="681839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42297" y="5848783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cxnSp>
        <p:nvCxnSpPr>
          <p:cNvPr id="34" name="Curved Connector 33"/>
          <p:cNvCxnSpPr/>
          <p:nvPr/>
        </p:nvCxnSpPr>
        <p:spPr>
          <a:xfrm>
            <a:off x="2306538" y="5411597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urved Connector 34"/>
          <p:cNvCxnSpPr/>
          <p:nvPr/>
        </p:nvCxnSpPr>
        <p:spPr>
          <a:xfrm>
            <a:off x="6803423" y="5603571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urved Connector 35"/>
          <p:cNvCxnSpPr/>
          <p:nvPr/>
        </p:nvCxnSpPr>
        <p:spPr>
          <a:xfrm>
            <a:off x="2394020" y="5876000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658942" y="6934516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151470" y="6934516"/>
            <a:ext cx="3557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Is56; aak-1(tm1944); aak-2(ok524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Curved Connector 39"/>
          <p:cNvCxnSpPr/>
          <p:nvPr/>
        </p:nvCxnSpPr>
        <p:spPr>
          <a:xfrm>
            <a:off x="2105331" y="5929757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4288581" y="12006865"/>
            <a:ext cx="0" cy="1201003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86363" y="11138629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cxnSp>
        <p:nvCxnSpPr>
          <p:cNvPr id="43" name="Curved Connector 42"/>
          <p:cNvCxnSpPr/>
          <p:nvPr/>
        </p:nvCxnSpPr>
        <p:spPr>
          <a:xfrm>
            <a:off x="6764211" y="5903824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urved Connector 43"/>
          <p:cNvCxnSpPr/>
          <p:nvPr/>
        </p:nvCxnSpPr>
        <p:spPr>
          <a:xfrm>
            <a:off x="7322299" y="5737570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4319236" y="14574650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273301" y="13539866"/>
            <a:ext cx="34740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GFP+ isolates, store at 25C to induce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cover induced-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GFP+ plates at 15C,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worms for genotyping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Oval 47"/>
          <p:cNvSpPr/>
          <p:nvPr/>
        </p:nvSpPr>
        <p:spPr>
          <a:xfrm>
            <a:off x="2758309" y="15470889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Oval 48"/>
          <p:cNvSpPr/>
          <p:nvPr/>
        </p:nvSpPr>
        <p:spPr>
          <a:xfrm>
            <a:off x="3159051" y="15470889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/>
          <p:nvPr/>
        </p:nvSpPr>
        <p:spPr>
          <a:xfrm>
            <a:off x="3582101" y="15470889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/>
          <p:cNvSpPr/>
          <p:nvPr/>
        </p:nvSpPr>
        <p:spPr>
          <a:xfrm>
            <a:off x="3996267" y="15470889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Oval 51"/>
          <p:cNvSpPr/>
          <p:nvPr/>
        </p:nvSpPr>
        <p:spPr>
          <a:xfrm>
            <a:off x="4388431" y="15470889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4797528" y="1549003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/>
          <p:cNvSpPr/>
          <p:nvPr/>
        </p:nvSpPr>
        <p:spPr>
          <a:xfrm>
            <a:off x="5196504" y="1549003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55"/>
          <p:cNvSpPr/>
          <p:nvPr/>
        </p:nvSpPr>
        <p:spPr>
          <a:xfrm>
            <a:off x="5588463" y="1549003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5170988" y="16009815"/>
            <a:ext cx="3570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isolates at 15C for genotyping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16613" y="16507856"/>
            <a:ext cx="844759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S: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daf-7(e1372) and aak-1(tm1944) are on the same chromosome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36 isolates were made for genotyping. This yielded four isolates negative for the aak-1 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ele. One of these was also negative for aak-2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Curved Connector 60"/>
          <p:cNvCxnSpPr/>
          <p:nvPr/>
        </p:nvCxnSpPr>
        <p:spPr>
          <a:xfrm>
            <a:off x="3509783" y="13262411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urved Connector 61"/>
          <p:cNvCxnSpPr/>
          <p:nvPr/>
        </p:nvCxnSpPr>
        <p:spPr>
          <a:xfrm>
            <a:off x="3470571" y="13562664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urved Connector 62"/>
          <p:cNvCxnSpPr/>
          <p:nvPr/>
        </p:nvCxnSpPr>
        <p:spPr>
          <a:xfrm>
            <a:off x="4028659" y="13396410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953840" y="5841853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Curved Connector 63"/>
          <p:cNvCxnSpPr/>
          <p:nvPr/>
        </p:nvCxnSpPr>
        <p:spPr>
          <a:xfrm>
            <a:off x="1996894" y="392668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Oval 64"/>
          <p:cNvSpPr/>
          <p:nvPr/>
        </p:nvSpPr>
        <p:spPr>
          <a:xfrm>
            <a:off x="1489597" y="803922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6" name="Straight Arrow Connector 65"/>
          <p:cNvCxnSpPr/>
          <p:nvPr/>
        </p:nvCxnSpPr>
        <p:spPr>
          <a:xfrm flipH="1">
            <a:off x="1649320" y="1115517"/>
            <a:ext cx="1250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flipH="1">
            <a:off x="1474184" y="1277216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 flipV="1">
            <a:off x="1792114" y="681839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urved Connector 68"/>
          <p:cNvCxnSpPr/>
          <p:nvPr/>
        </p:nvCxnSpPr>
        <p:spPr>
          <a:xfrm>
            <a:off x="6661523" y="407682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 flipV="1">
            <a:off x="6360814" y="826152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Oval 70"/>
          <p:cNvSpPr/>
          <p:nvPr/>
        </p:nvSpPr>
        <p:spPr>
          <a:xfrm rot="1200000">
            <a:off x="6093800" y="985995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2" name="Straight Arrow Connector 71"/>
          <p:cNvCxnSpPr/>
          <p:nvPr/>
        </p:nvCxnSpPr>
        <p:spPr>
          <a:xfrm flipV="1">
            <a:off x="6360813" y="6083583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Oval 72"/>
          <p:cNvSpPr/>
          <p:nvPr/>
        </p:nvSpPr>
        <p:spPr>
          <a:xfrm rot="1200000">
            <a:off x="6093799" y="6243426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Oval 73"/>
          <p:cNvSpPr/>
          <p:nvPr/>
        </p:nvSpPr>
        <p:spPr>
          <a:xfrm>
            <a:off x="1529720" y="6218393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5" name="Straight Arrow Connector 74"/>
          <p:cNvCxnSpPr/>
          <p:nvPr/>
        </p:nvCxnSpPr>
        <p:spPr>
          <a:xfrm flipH="1">
            <a:off x="1689443" y="6529988"/>
            <a:ext cx="1250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flipH="1">
            <a:off x="1514307" y="6691687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flipV="1">
            <a:off x="1832237" y="6096310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Oval 81"/>
          <p:cNvSpPr/>
          <p:nvPr/>
        </p:nvSpPr>
        <p:spPr>
          <a:xfrm>
            <a:off x="1474184" y="11575385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3" name="Straight Arrow Connector 82"/>
          <p:cNvCxnSpPr/>
          <p:nvPr/>
        </p:nvCxnSpPr>
        <p:spPr>
          <a:xfrm flipH="1">
            <a:off x="1633907" y="11886980"/>
            <a:ext cx="1250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flipH="1">
            <a:off x="1458771" y="12048679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 flipV="1">
            <a:off x="1776701" y="11453302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 flipV="1">
            <a:off x="6228949" y="11424006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Oval 86"/>
          <p:cNvSpPr/>
          <p:nvPr/>
        </p:nvSpPr>
        <p:spPr>
          <a:xfrm rot="1200000">
            <a:off x="5961935" y="11583849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8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urved Connector 4"/>
          <p:cNvCxnSpPr/>
          <p:nvPr/>
        </p:nvCxnSpPr>
        <p:spPr>
          <a:xfrm>
            <a:off x="6713948" y="392668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urved Connector 5"/>
          <p:cNvCxnSpPr/>
          <p:nvPr/>
        </p:nvCxnSpPr>
        <p:spPr>
          <a:xfrm>
            <a:off x="1996894" y="392668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986123" y="596949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>
            <a:stCxn id="7" idx="2"/>
          </p:cNvCxnSpPr>
          <p:nvPr/>
        </p:nvCxnSpPr>
        <p:spPr>
          <a:xfrm>
            <a:off x="4300472" y="1427946"/>
            <a:ext cx="0" cy="1201003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215762" y="1703308"/>
            <a:ext cx="20171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Is56; daf-7(e1372)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+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235948" y="1702303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-16(m27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681323" y="2771188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4300472" y="3306484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3681323" y="4239081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208922" y="2652711"/>
            <a:ext cx="3499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at 25C to induce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worms that are non-quiescent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18665" y="4120604"/>
            <a:ext cx="35637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 isolates at 22C, move isolates 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5C, then heat shock for males</a:t>
            </a:r>
          </a:p>
        </p:txBody>
      </p:sp>
      <p:cxnSp>
        <p:nvCxnSpPr>
          <p:cNvPr id="26" name="Straight Arrow Connector 25"/>
          <p:cNvCxnSpPr/>
          <p:nvPr/>
        </p:nvCxnSpPr>
        <p:spPr>
          <a:xfrm flipV="1">
            <a:off x="6484437" y="826422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Oval 47"/>
          <p:cNvSpPr/>
          <p:nvPr/>
        </p:nvSpPr>
        <p:spPr>
          <a:xfrm>
            <a:off x="1489597" y="803922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Arrow Connector 48"/>
          <p:cNvCxnSpPr/>
          <p:nvPr/>
        </p:nvCxnSpPr>
        <p:spPr>
          <a:xfrm>
            <a:off x="1650570" y="1115517"/>
            <a:ext cx="1767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1474184" y="1277216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flipV="1">
            <a:off x="1792114" y="681839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Oval 54"/>
          <p:cNvSpPr/>
          <p:nvPr/>
        </p:nvSpPr>
        <p:spPr>
          <a:xfrm rot="1200000">
            <a:off x="6217423" y="986265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8" name="Curved Connector 57"/>
          <p:cNvCxnSpPr/>
          <p:nvPr/>
        </p:nvCxnSpPr>
        <p:spPr>
          <a:xfrm>
            <a:off x="2205448" y="5588497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endCxn id="62" idx="0"/>
          </p:cNvCxnSpPr>
          <p:nvPr/>
        </p:nvCxnSpPr>
        <p:spPr>
          <a:xfrm>
            <a:off x="4300472" y="4894426"/>
            <a:ext cx="0" cy="1135105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urved Connector 59"/>
          <p:cNvCxnSpPr/>
          <p:nvPr/>
        </p:nvCxnSpPr>
        <p:spPr>
          <a:xfrm>
            <a:off x="6931751" y="5895697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urved Connector 60"/>
          <p:cNvCxnSpPr/>
          <p:nvPr/>
        </p:nvCxnSpPr>
        <p:spPr>
          <a:xfrm>
            <a:off x="2292930" y="6052900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3986123" y="6029531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660528" y="7134365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6225471" y="7051896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Curved Connector 64"/>
          <p:cNvCxnSpPr/>
          <p:nvPr/>
        </p:nvCxnSpPr>
        <p:spPr>
          <a:xfrm>
            <a:off x="6510419" y="5862737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urved Connector 65"/>
          <p:cNvCxnSpPr/>
          <p:nvPr/>
        </p:nvCxnSpPr>
        <p:spPr>
          <a:xfrm>
            <a:off x="7445139" y="6131053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urved Connector 66"/>
          <p:cNvCxnSpPr/>
          <p:nvPr/>
        </p:nvCxnSpPr>
        <p:spPr>
          <a:xfrm>
            <a:off x="2004241" y="6106657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4338178" y="6889161"/>
            <a:ext cx="0" cy="1201003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Oval 71"/>
          <p:cNvSpPr/>
          <p:nvPr/>
        </p:nvSpPr>
        <p:spPr>
          <a:xfrm>
            <a:off x="1493761" y="6450239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3" name="Straight Arrow Connector 72"/>
          <p:cNvCxnSpPr/>
          <p:nvPr/>
        </p:nvCxnSpPr>
        <p:spPr>
          <a:xfrm flipH="1">
            <a:off x="1653484" y="6761834"/>
            <a:ext cx="1250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flipH="1">
            <a:off x="1478348" y="6923533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V="1">
            <a:off x="1796278" y="6328156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flipV="1">
            <a:off x="6191545" y="6282307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Oval 76"/>
          <p:cNvSpPr/>
          <p:nvPr/>
        </p:nvSpPr>
        <p:spPr>
          <a:xfrm rot="1200000">
            <a:off x="5924531" y="6442150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3727758" y="8184660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9" name="Straight Arrow Connector 78"/>
          <p:cNvCxnSpPr/>
          <p:nvPr/>
        </p:nvCxnSpPr>
        <p:spPr>
          <a:xfrm>
            <a:off x="4346907" y="8719956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3727758" y="9652553"/>
            <a:ext cx="1247847" cy="3759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/>
          <p:cNvSpPr txBox="1"/>
          <p:nvPr/>
        </p:nvSpPr>
        <p:spPr>
          <a:xfrm>
            <a:off x="5255357" y="8066183"/>
            <a:ext cx="3499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ore at 25C to induce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</a:p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k worms that are non-quiescent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265094" y="9534076"/>
            <a:ext cx="35637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 isolates at 22C, move isolates 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C, p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k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+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4397224" y="10275515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2888224" y="17450075"/>
            <a:ext cx="347405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eated isolated populations to test for 2% SDS resistance (</a:t>
            </a:r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 </a:t>
            </a:r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on Page 3).</a:t>
            </a:r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Oval 85"/>
          <p:cNvSpPr/>
          <p:nvPr/>
        </p:nvSpPr>
        <p:spPr>
          <a:xfrm>
            <a:off x="2805125" y="11221860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Oval 86"/>
          <p:cNvSpPr/>
          <p:nvPr/>
        </p:nvSpPr>
        <p:spPr>
          <a:xfrm>
            <a:off x="3205867" y="11221860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Oval 87"/>
          <p:cNvSpPr/>
          <p:nvPr/>
        </p:nvSpPr>
        <p:spPr>
          <a:xfrm>
            <a:off x="3628917" y="11221860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Oval 88"/>
          <p:cNvSpPr/>
          <p:nvPr/>
        </p:nvSpPr>
        <p:spPr>
          <a:xfrm>
            <a:off x="4043083" y="11221860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Oval 89"/>
          <p:cNvSpPr/>
          <p:nvPr/>
        </p:nvSpPr>
        <p:spPr>
          <a:xfrm>
            <a:off x="4435247" y="11221860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Oval 90"/>
          <p:cNvSpPr/>
          <p:nvPr/>
        </p:nvSpPr>
        <p:spPr>
          <a:xfrm>
            <a:off x="4842583" y="1121384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Oval 91"/>
          <p:cNvSpPr/>
          <p:nvPr/>
        </p:nvSpPr>
        <p:spPr>
          <a:xfrm>
            <a:off x="5241559" y="1121384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Oval 92"/>
          <p:cNvSpPr/>
          <p:nvPr/>
        </p:nvSpPr>
        <p:spPr>
          <a:xfrm>
            <a:off x="5633518" y="11213848"/>
            <a:ext cx="311702" cy="30253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4" name="Curved Connector 93"/>
          <p:cNvCxnSpPr/>
          <p:nvPr/>
        </p:nvCxnSpPr>
        <p:spPr>
          <a:xfrm>
            <a:off x="3628585" y="13346476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urved Connector 94"/>
          <p:cNvCxnSpPr/>
          <p:nvPr/>
        </p:nvCxnSpPr>
        <p:spPr>
          <a:xfrm>
            <a:off x="3589373" y="13646729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urved Connector 95"/>
          <p:cNvCxnSpPr/>
          <p:nvPr/>
        </p:nvCxnSpPr>
        <p:spPr>
          <a:xfrm>
            <a:off x="4147461" y="13480475"/>
            <a:ext cx="934720" cy="792480"/>
          </a:xfrm>
          <a:prstGeom prst="curvedConnector3">
            <a:avLst/>
          </a:prstGeom>
          <a:ln w="635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417199" y="637558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3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82875" y="6333559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657590" y="11679855"/>
            <a:ext cx="77747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s were synchronized at L1 and then stored at 25C for three days. Isolates with no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L4/adult worms) were selecte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Straight Arrow Connector 68"/>
          <p:cNvCxnSpPr/>
          <p:nvPr/>
        </p:nvCxnSpPr>
        <p:spPr>
          <a:xfrm>
            <a:off x="4469860" y="16561278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urved Connector 69"/>
          <p:cNvCxnSpPr/>
          <p:nvPr/>
        </p:nvCxnSpPr>
        <p:spPr>
          <a:xfrm>
            <a:off x="2374836" y="15266885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>
            <a:endCxn id="102" idx="0"/>
          </p:cNvCxnSpPr>
          <p:nvPr/>
        </p:nvCxnSpPr>
        <p:spPr>
          <a:xfrm>
            <a:off x="4469860" y="14572814"/>
            <a:ext cx="0" cy="1135105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urved Connector 96"/>
          <p:cNvCxnSpPr/>
          <p:nvPr/>
        </p:nvCxnSpPr>
        <p:spPr>
          <a:xfrm>
            <a:off x="7101139" y="15574085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urved Connector 100"/>
          <p:cNvCxnSpPr/>
          <p:nvPr/>
        </p:nvCxnSpPr>
        <p:spPr>
          <a:xfrm>
            <a:off x="2462318" y="15731288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4155511" y="15707919"/>
            <a:ext cx="6286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US" sz="4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829916" y="16812753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6394859" y="16730284"/>
            <a:ext cx="1081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FP +/-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Curved Connector 105"/>
          <p:cNvCxnSpPr/>
          <p:nvPr/>
        </p:nvCxnSpPr>
        <p:spPr>
          <a:xfrm>
            <a:off x="6679807" y="15541125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urved Connector 106"/>
          <p:cNvCxnSpPr/>
          <p:nvPr/>
        </p:nvCxnSpPr>
        <p:spPr>
          <a:xfrm>
            <a:off x="7614527" y="15809441"/>
            <a:ext cx="934720" cy="792480"/>
          </a:xfrm>
          <a:prstGeom prst="curvedConnector3">
            <a:avLst/>
          </a:prstGeom>
          <a:ln w="635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urved Connector 107"/>
          <p:cNvCxnSpPr/>
          <p:nvPr/>
        </p:nvCxnSpPr>
        <p:spPr>
          <a:xfrm>
            <a:off x="2173629" y="15785045"/>
            <a:ext cx="934720" cy="792480"/>
          </a:xfrm>
          <a:prstGeom prst="curvedConnector3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Oval 108"/>
          <p:cNvSpPr/>
          <p:nvPr/>
        </p:nvSpPr>
        <p:spPr>
          <a:xfrm>
            <a:off x="1663149" y="16128627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0" name="Straight Arrow Connector 109"/>
          <p:cNvCxnSpPr/>
          <p:nvPr/>
        </p:nvCxnSpPr>
        <p:spPr>
          <a:xfrm flipH="1">
            <a:off x="1822872" y="16440222"/>
            <a:ext cx="1250" cy="304987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 flipH="1">
            <a:off x="1647736" y="16601921"/>
            <a:ext cx="352772" cy="4011"/>
          </a:xfrm>
          <a:prstGeom prst="straightConnector1">
            <a:avLst/>
          </a:prstGeom>
          <a:ln w="635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 flipV="1">
            <a:off x="1965666" y="16006544"/>
            <a:ext cx="204780" cy="173297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/>
          <p:cNvCxnSpPr/>
          <p:nvPr/>
        </p:nvCxnSpPr>
        <p:spPr>
          <a:xfrm flipV="1">
            <a:off x="6360933" y="15960695"/>
            <a:ext cx="229511" cy="193143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Oval 113"/>
          <p:cNvSpPr/>
          <p:nvPr/>
        </p:nvSpPr>
        <p:spPr>
          <a:xfrm rot="1200000">
            <a:off x="6093919" y="16120538"/>
            <a:ext cx="337359" cy="313605"/>
          </a:xfrm>
          <a:prstGeom prst="ellipse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TextBox 114"/>
          <p:cNvSpPr txBox="1"/>
          <p:nvPr/>
        </p:nvSpPr>
        <p:spPr>
          <a:xfrm>
            <a:off x="652263" y="16011947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3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cxnSp>
        <p:nvCxnSpPr>
          <p:cNvPr id="116" name="Straight Arrow Connector 115"/>
          <p:cNvCxnSpPr/>
          <p:nvPr/>
        </p:nvCxnSpPr>
        <p:spPr>
          <a:xfrm>
            <a:off x="4405758" y="12442156"/>
            <a:ext cx="17068" cy="805598"/>
          </a:xfrm>
          <a:prstGeom prst="straightConnector1">
            <a:avLst/>
          </a:prstGeom>
          <a:ln w="190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41114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4528714"/>
              </p:ext>
            </p:extLst>
          </p:nvPr>
        </p:nvGraphicFramePr>
        <p:xfrm>
          <a:off x="1058779" y="8009857"/>
          <a:ext cx="7202907" cy="148406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87116"/>
                <a:gridCol w="1556084"/>
                <a:gridCol w="1540042"/>
                <a:gridCol w="1572127"/>
                <a:gridCol w="1347538"/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0" dirty="0">
                          <a:effectLst/>
                        </a:rPr>
                        <a:t>F</a:t>
                      </a:r>
                      <a:r>
                        <a:rPr lang="en-US" sz="1200" kern="1000" baseline="-25000" dirty="0">
                          <a:effectLst/>
                        </a:rPr>
                        <a:t>2</a:t>
                      </a:r>
                      <a:endParaRPr lang="en-US" sz="1200" kern="10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kern="1000" dirty="0">
                          <a:effectLst/>
                        </a:rPr>
                        <a:t> </a:t>
                      </a:r>
                      <a:endParaRPr lang="en-US" sz="1200" kern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Mature Dau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In-situ Dau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 dirty="0">
                          <a:effectLst/>
                        </a:rPr>
                        <a:t>Overlap - Both (%)</a:t>
                      </a:r>
                      <a:endParaRPr lang="en-US" sz="1200" kern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Neith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Survivors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32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21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21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26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TOTAL (N = 19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0" dirty="0">
                          <a:effectLst/>
                        </a:rPr>
                        <a:t>F</a:t>
                      </a:r>
                      <a:r>
                        <a:rPr lang="en-US" sz="1200" kern="1000" baseline="-25000" dirty="0">
                          <a:effectLst/>
                        </a:rPr>
                        <a:t>3</a:t>
                      </a:r>
                      <a:endParaRPr lang="en-US" sz="1200" kern="10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600" kern="1000" dirty="0">
                          <a:effectLst/>
                        </a:rPr>
                        <a:t> </a:t>
                      </a:r>
                      <a:endParaRPr lang="en-US" sz="1200" kern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Mature Dau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In-situ Dau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Overlap - Both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Neither (%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Survivors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5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5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28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7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TOTAL</a:t>
                      </a:r>
                      <a:endParaRPr lang="en-US" sz="1200" kern="10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(N = 18)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>
                          <a:effectLst/>
                        </a:rPr>
                        <a:t>100</a:t>
                      </a:r>
                      <a:endParaRPr lang="en-US" sz="1200" kern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000" dirty="0">
                          <a:effectLst/>
                        </a:rPr>
                        <a:t>100</a:t>
                      </a:r>
                      <a:endParaRPr lang="en-US" sz="1200" kern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058778" y="7469119"/>
            <a:ext cx="7202907" cy="50013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olated population of daf-7 (e1372); daf-16 (m27) crosses, survival of SDS (2%) at 30 minutes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7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ure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ans that plate was treated when plate was full but not starved,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-situ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ans that plate was treated after a period of starvation (10-12d).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lap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eans that survivors were observed for both treatments (mature and in-situ)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R="0" lvl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ither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tegory was interpreted as not being able to survive SDS treatment.</a:t>
            </a:r>
          </a:p>
          <a:p>
            <a:pPr marL="171450" marR="0" lvl="0" indent="-17145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marR="0" lvl="0" indent="-17145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R="0" lvl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taken together,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ure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-situ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”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tegories can be interpreted as heterozygous for </a:t>
            </a:r>
            <a:r>
              <a:rPr kumimoji="0" lang="en-US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uer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mation.</a:t>
            </a:r>
          </a:p>
          <a:p>
            <a:pPr marL="171450" marR="0" lvl="0" indent="-17145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marR="0" lvl="0" indent="-17145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kumimoji="0" lang="en-US" alt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percentage of survivors refers to the number of plates where at least one survivor was observed (generally a long, thin worm at L3/L4 stage). The number of survivor in each plate was generally quite low (no more than 7 worms were ever observed per plate), making the total number of survivors per number of input worms infinitesimally small (estimated rate: 0.02%)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4936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506</Words>
  <Application>Microsoft Office PowerPoint</Application>
  <PresentationFormat>Custom</PresentationFormat>
  <Paragraphs>1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y Alicea</dc:creator>
  <cp:lastModifiedBy>Bradly Alicea</cp:lastModifiedBy>
  <cp:revision>22</cp:revision>
  <dcterms:created xsi:type="dcterms:W3CDTF">2015-12-16T16:44:51Z</dcterms:created>
  <dcterms:modified xsi:type="dcterms:W3CDTF">2016-02-19T19:13:03Z</dcterms:modified>
</cp:coreProperties>
</file>